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4" d="100"/>
          <a:sy n="114" d="100"/>
        </p:scale>
        <p:origin x="4172"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5185503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3629835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15417251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293893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34330255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22141856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4096979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4923665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13123808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28344074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C6DF516-0358-4BD7-9BC8-B837F742A94B}"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1334578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C6DF516-0358-4BD7-9BC8-B837F742A94B}" type="datetimeFigureOut">
              <a:rPr lang="zh-CN" altLang="en-US" smtClean="0"/>
              <a:t>2021/8/22</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2B05D39-1885-4373-A193-3C988805F903}" type="slidenum">
              <a:rPr lang="zh-CN" altLang="en-US" smtClean="0"/>
              <a:t>‹#›</a:t>
            </a:fld>
            <a:endParaRPr lang="zh-CN" altLang="en-US"/>
          </a:p>
        </p:txBody>
      </p:sp>
    </p:spTree>
    <p:extLst>
      <p:ext uri="{BB962C8B-B14F-4D97-AF65-F5344CB8AC3E}">
        <p14:creationId xmlns:p14="http://schemas.microsoft.com/office/powerpoint/2010/main" val="35406147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AE7D2483-1D22-4262-B08F-1EF9493A8D53}"/>
              </a:ext>
            </a:extLst>
          </p:cNvPr>
          <p:cNvSpPr txBox="1"/>
          <p:nvPr/>
        </p:nvSpPr>
        <p:spPr>
          <a:xfrm>
            <a:off x="196589" y="367250"/>
            <a:ext cx="6464815" cy="2552109"/>
          </a:xfrm>
          <a:prstGeom prst="rect">
            <a:avLst/>
          </a:prstGeom>
          <a:noFill/>
        </p:spPr>
        <p:txBody>
          <a:bodyPr wrap="square">
            <a:spAutoFit/>
          </a:bodyPr>
          <a:lstStyle/>
          <a:p>
            <a:pPr algn="just">
              <a:lnSpc>
                <a:spcPct val="150000"/>
              </a:lnSpc>
            </a:pPr>
            <a:r>
              <a:rPr lang="en-US" altLang="zh-CN" sz="1200" b="1"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Supplementary Figure S1. </a:t>
            </a:r>
            <a:r>
              <a:rPr lang="en-US" altLang="zh-CN" sz="1200"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rPr>
              <a:t>Comparison of healthy and bitter pit ‘Fuji’ apples. (A) At maturity, fruit with bitter pit on the tree, (B) healthy fruit, (C) fruit with bitter pit, (D) and the cut site of fruit with bitter pit.</a:t>
            </a:r>
            <a:endParaRPr lang="zh-CN" altLang="zh-CN" sz="1200" dirty="0">
              <a:effectLst/>
              <a:latin typeface="Times New Roman" panose="02020603050405020304" pitchFamily="18" charset="0"/>
              <a:ea typeface="宋体" panose="02010600030101010101" pitchFamily="2" charset="-122"/>
              <a:cs typeface="Times New Roman" panose="02020603050405020304" pitchFamily="18" charset="0"/>
            </a:endParaRPr>
          </a:p>
          <a:p>
            <a:pPr indent="301625" algn="just">
              <a:lnSpc>
                <a:spcPct val="150000"/>
              </a:lnSpc>
            </a:pPr>
            <a:r>
              <a:rPr lang="en-US" altLang="zh-CN" sz="120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Generally, there were no spots on the outer epidermis of the healthy fruits (Figure S1B), but fruits with bitter pit had several lesions in the outer peel (Figure S1C). Most of the lesions occurred near the calyx end and rarely occurred near the fruit stalk (Supplementary Figure S1C). In the diseased part, the pulp under the peel developed brown lesions initially and then the symptoms spread to the outer skin. During the late stage of the disease, the flesh shrinks, and the epidermis becomes necrotic. The dark brown spots are 2–3 mm deep and the fruit has a bitter taste (Supplementary Figure S1D). </a:t>
            </a:r>
            <a:endParaRPr lang="zh-CN" altLang="zh-CN"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pic>
        <p:nvPicPr>
          <p:cNvPr id="6" name="图片 5" descr="绿色的苹果&#10;&#10;描述已自动生成">
            <a:extLst>
              <a:ext uri="{FF2B5EF4-FFF2-40B4-BE49-F238E27FC236}">
                <a16:creationId xmlns:a16="http://schemas.microsoft.com/office/drawing/2014/main" id="{3F3DC9D3-91B7-4298-A9B5-DF0654D3016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1332" y="3127284"/>
            <a:ext cx="6115331" cy="5749243"/>
          </a:xfrm>
          <a:prstGeom prst="rect">
            <a:avLst/>
          </a:prstGeom>
        </p:spPr>
      </p:pic>
    </p:spTree>
    <p:extLst>
      <p:ext uri="{BB962C8B-B14F-4D97-AF65-F5344CB8AC3E}">
        <p14:creationId xmlns:p14="http://schemas.microsoft.com/office/powerpoint/2010/main" val="1762911222"/>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6</TotalTime>
  <Words>173</Words>
  <Application>Microsoft Office PowerPoint</Application>
  <PresentationFormat>A4 纸张(210x297 毫米)</PresentationFormat>
  <Paragraphs>2</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qu haiyong</dc:creator>
  <cp:lastModifiedBy>qu haiyong</cp:lastModifiedBy>
  <cp:revision>11</cp:revision>
  <dcterms:created xsi:type="dcterms:W3CDTF">2020-09-13T04:09:29Z</dcterms:created>
  <dcterms:modified xsi:type="dcterms:W3CDTF">2021-08-21T17:51:00Z</dcterms:modified>
</cp:coreProperties>
</file>